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44">
          <p15:clr>
            <a:srgbClr val="A4A3A4"/>
          </p15:clr>
        </p15:guide>
        <p15:guide id="2" pos="15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631" autoAdjust="0"/>
  </p:normalViewPr>
  <p:slideViewPr>
    <p:cSldViewPr snapToGrid="0">
      <p:cViewPr varScale="1">
        <p:scale>
          <a:sx n="77" d="100"/>
          <a:sy n="77" d="100"/>
        </p:scale>
        <p:origin x="1372" y="72"/>
      </p:cViewPr>
      <p:guideLst>
        <p:guide orient="horz" pos="2744"/>
        <p:guide pos="15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3" descr="C:\Users\win10\Desktop\原始条带\抗生素\O12.tif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8315" y="5028859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C:\Users\win10\Desktop\原始条带\抗生素\gapdh1.tif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3281" y="5697324"/>
            <a:ext cx="2520000" cy="360362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0"/>
            <a:ext cx="35473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Original bands for Figure 2B</a:t>
            </a:r>
          </a:p>
          <a:p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235"/>
          <p:cNvSpPr txBox="1"/>
          <p:nvPr/>
        </p:nvSpPr>
        <p:spPr>
          <a:xfrm>
            <a:off x="-9737" y="1086852"/>
            <a:ext cx="11676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ZO-1</a:t>
            </a:r>
          </a:p>
          <a:p>
            <a:pPr algn="ctr"/>
            <a:r>
              <a:rPr lang="zh-CN" altLang="en-US" sz="1200" b="1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zh-CN" sz="1200" b="1">
                <a:latin typeface="Arial" pitchFamily="34" charset="0"/>
                <a:cs typeface="Arial" pitchFamily="34" charset="0"/>
              </a:rPr>
              <a:t>195kDa</a:t>
            </a:r>
            <a:r>
              <a:rPr lang="zh-CN" altLang="en-US" sz="1200" b="1">
                <a:latin typeface="Arial" pitchFamily="34" charset="0"/>
                <a:cs typeface="Arial" pitchFamily="34" charset="0"/>
              </a:rPr>
              <a:t>）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win10\Desktop\原始条带\无抗生素\GAPDH 12.tif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315" y="2374069"/>
            <a:ext cx="2160000" cy="36000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win10\Desktop\原始条带\无抗生素\OCC 12.tif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315" y="1798906"/>
            <a:ext cx="2160000" cy="36000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win10\Desktop\原始条带\无抗生素\ZO 12.tif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0892" y="1040060"/>
            <a:ext cx="216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win10\Desktop\原始条带\无抗生素\ZO 34.tif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315" y="1032862"/>
            <a:ext cx="216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win10\Desktop\原始条带\无抗生素\GAPDH 34.tif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1457" y="2374069"/>
            <a:ext cx="2160000" cy="360363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win10\Desktop\原始条带\无抗生素\OCC 56.tif"/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8797" y="1795117"/>
            <a:ext cx="2160000" cy="36000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win10\Desktop\原始条带\无抗生素\OCC 34.tif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1139" y="1798906"/>
            <a:ext cx="2160000" cy="360363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win10\Desktop\原始条带\无抗生素\ZO 56.tif"/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8797" y="1040060"/>
            <a:ext cx="216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win10\Desktop\原始条带\无抗生素\GAPDH 56.tif"/>
          <p:cNvPicPr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8797" y="2374288"/>
            <a:ext cx="2160000" cy="360362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235"/>
          <p:cNvSpPr txBox="1"/>
          <p:nvPr/>
        </p:nvSpPr>
        <p:spPr>
          <a:xfrm>
            <a:off x="0" y="1828117"/>
            <a:ext cx="11676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Occludin</a:t>
            </a:r>
          </a:p>
          <a:p>
            <a:pPr algn="ctr"/>
            <a:r>
              <a:rPr lang="zh-CN" altLang="en-US" sz="1200" b="1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52kDa</a:t>
            </a:r>
            <a:r>
              <a:rPr lang="zh-CN" altLang="en-US" sz="1200" b="1" dirty="0">
                <a:latin typeface="Arial" pitchFamily="34" charset="0"/>
                <a:cs typeface="Arial" pitchFamily="34" charset="0"/>
              </a:rPr>
              <a:t>）</a:t>
            </a:r>
          </a:p>
        </p:txBody>
      </p:sp>
      <p:sp>
        <p:nvSpPr>
          <p:cNvPr id="15" name="TextBox 235"/>
          <p:cNvSpPr txBox="1"/>
          <p:nvPr/>
        </p:nvSpPr>
        <p:spPr>
          <a:xfrm>
            <a:off x="-9737" y="2347654"/>
            <a:ext cx="11676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GAPDH</a:t>
            </a:r>
          </a:p>
          <a:p>
            <a:pPr algn="ctr"/>
            <a:r>
              <a:rPr lang="zh-CN" altLang="en-US" sz="1200" b="1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37kDa</a:t>
            </a:r>
            <a:r>
              <a:rPr lang="zh-CN" altLang="en-US" sz="1200" b="1" dirty="0">
                <a:latin typeface="Arial" pitchFamily="34" charset="0"/>
                <a:cs typeface="Arial" pitchFamily="34" charset="0"/>
              </a:rPr>
              <a:t>）</a:t>
            </a:r>
          </a:p>
        </p:txBody>
      </p:sp>
      <p:grpSp>
        <p:nvGrpSpPr>
          <p:cNvPr id="2" name="组合 1"/>
          <p:cNvGrpSpPr/>
          <p:nvPr/>
        </p:nvGrpSpPr>
        <p:grpSpPr>
          <a:xfrm>
            <a:off x="816146" y="669800"/>
            <a:ext cx="1694284" cy="322901"/>
            <a:chOff x="816146" y="669800"/>
            <a:chExt cx="1694284" cy="322901"/>
          </a:xfrm>
        </p:grpSpPr>
        <p:sp>
          <p:nvSpPr>
            <p:cNvPr id="16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1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1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1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1639475" y="671887"/>
            <a:ext cx="1694284" cy="322901"/>
            <a:chOff x="816146" y="669800"/>
            <a:chExt cx="1694284" cy="322901"/>
          </a:xfrm>
        </p:grpSpPr>
        <p:sp>
          <p:nvSpPr>
            <p:cNvPr id="21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3368469" y="670796"/>
            <a:ext cx="1694284" cy="322901"/>
            <a:chOff x="816146" y="669800"/>
            <a:chExt cx="1694284" cy="322901"/>
          </a:xfrm>
        </p:grpSpPr>
        <p:sp>
          <p:nvSpPr>
            <p:cNvPr id="25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4196235" y="675554"/>
            <a:ext cx="1694284" cy="322901"/>
            <a:chOff x="816146" y="669800"/>
            <a:chExt cx="1694284" cy="322901"/>
          </a:xfrm>
        </p:grpSpPr>
        <p:sp>
          <p:nvSpPr>
            <p:cNvPr id="29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4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4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4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5836944" y="668519"/>
            <a:ext cx="1694284" cy="322901"/>
            <a:chOff x="816146" y="669800"/>
            <a:chExt cx="1694284" cy="322901"/>
          </a:xfrm>
        </p:grpSpPr>
        <p:sp>
          <p:nvSpPr>
            <p:cNvPr id="33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6699916" y="675429"/>
            <a:ext cx="1694284" cy="322901"/>
            <a:chOff x="816146" y="669800"/>
            <a:chExt cx="1694284" cy="322901"/>
          </a:xfrm>
        </p:grpSpPr>
        <p:sp>
          <p:nvSpPr>
            <p:cNvPr id="37" name="TextBox 235"/>
            <p:cNvSpPr txBox="1"/>
            <p:nvPr/>
          </p:nvSpPr>
          <p:spPr>
            <a:xfrm rot="2249819">
              <a:off x="816146" y="715702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C6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235"/>
            <p:cNvSpPr txBox="1"/>
            <p:nvPr/>
          </p:nvSpPr>
          <p:spPr>
            <a:xfrm rot="2249819">
              <a:off x="1080970" y="70656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NCD6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235"/>
            <p:cNvSpPr txBox="1"/>
            <p:nvPr/>
          </p:nvSpPr>
          <p:spPr>
            <a:xfrm rot="2249819">
              <a:off x="1342818" y="669800"/>
              <a:ext cx="116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OCD6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-36140" y="3064061"/>
            <a:ext cx="34409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Original bands for Figure 3B</a:t>
            </a:r>
          </a:p>
          <a:p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235"/>
          <p:cNvSpPr txBox="1"/>
          <p:nvPr/>
        </p:nvSpPr>
        <p:spPr>
          <a:xfrm>
            <a:off x="-38921" y="4410469"/>
            <a:ext cx="11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ZO-1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235"/>
          <p:cNvSpPr txBox="1"/>
          <p:nvPr/>
        </p:nvSpPr>
        <p:spPr>
          <a:xfrm>
            <a:off x="-29184" y="5151734"/>
            <a:ext cx="11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Occludin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235"/>
          <p:cNvSpPr txBox="1"/>
          <p:nvPr/>
        </p:nvSpPr>
        <p:spPr>
          <a:xfrm>
            <a:off x="-38921" y="5739367"/>
            <a:ext cx="11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99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39800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096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795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8494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4193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89299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559198" algn="l" defTabSz="1139800" rtl="0" eaLnBrk="1" latinLnBrk="0" hangingPunct="1"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GAPDH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281303" y="1148507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180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8279885" y="1325214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130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8281303" y="1449005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100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289613" y="1732210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70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8281687" y="1866340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55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8279885" y="2401409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itchFamily="34" charset="0"/>
                <a:cs typeface="Arial" pitchFamily="34" charset="0"/>
              </a:rPr>
              <a:t>35kDa</a:t>
            </a:r>
            <a:endParaRPr lang="zh-CN" altLang="en-US" sz="10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Picture 4" descr="C:\Users\win10\Desktop\原始条带\抗生素\ZO12.tif"/>
          <p:cNvPicPr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3281" y="4391377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6" descr="C:\Users\win10\Desktop\原始条带\抗生素\O34.tif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2570" y="5028517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8" descr="C:\Users\win10\Desktop\原始条带\抗生素\ZO56.tif"/>
          <p:cNvPicPr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5419" y="4403171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9" descr="C:\Users\win10\Desktop\原始条带\抗生素\O56.tif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1307" y="5028859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7" name="组合 76"/>
          <p:cNvGrpSpPr/>
          <p:nvPr/>
        </p:nvGrpSpPr>
        <p:grpSpPr>
          <a:xfrm>
            <a:off x="322092" y="3835764"/>
            <a:ext cx="2162024" cy="323653"/>
            <a:chOff x="322092" y="3835764"/>
            <a:chExt cx="2162024" cy="323653"/>
          </a:xfrm>
        </p:grpSpPr>
        <p:grpSp>
          <p:nvGrpSpPr>
            <p:cNvPr id="53" name="组合 52"/>
            <p:cNvGrpSpPr/>
            <p:nvPr/>
          </p:nvGrpSpPr>
          <p:grpSpPr>
            <a:xfrm>
              <a:off x="322092" y="3835764"/>
              <a:ext cx="1897815" cy="323653"/>
              <a:chOff x="750124" y="609427"/>
              <a:chExt cx="1897815" cy="323653"/>
            </a:xfrm>
          </p:grpSpPr>
          <p:sp>
            <p:nvSpPr>
              <p:cNvPr id="54" name="TextBox 235"/>
              <p:cNvSpPr txBox="1"/>
              <p:nvPr/>
            </p:nvSpPr>
            <p:spPr>
              <a:xfrm rot="2249819">
                <a:off x="750124" y="654258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1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TextBox 235"/>
              <p:cNvSpPr txBox="1"/>
              <p:nvPr/>
            </p:nvSpPr>
            <p:spPr>
              <a:xfrm rot="2249819">
                <a:off x="989649" y="656081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1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TextBox 235"/>
              <p:cNvSpPr txBox="1"/>
              <p:nvPr/>
            </p:nvSpPr>
            <p:spPr>
              <a:xfrm rot="2249819">
                <a:off x="1094212" y="609427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1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2" name="TextBox 235"/>
            <p:cNvSpPr txBox="1"/>
            <p:nvPr/>
          </p:nvSpPr>
          <p:spPr>
            <a:xfrm rot="2249819">
              <a:off x="930389" y="3836942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1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4" name="组合 93"/>
          <p:cNvGrpSpPr/>
          <p:nvPr/>
        </p:nvGrpSpPr>
        <p:grpSpPr>
          <a:xfrm>
            <a:off x="1367406" y="3825893"/>
            <a:ext cx="2162024" cy="323653"/>
            <a:chOff x="322092" y="3838145"/>
            <a:chExt cx="2162024" cy="323653"/>
          </a:xfrm>
        </p:grpSpPr>
        <p:grpSp>
          <p:nvGrpSpPr>
            <p:cNvPr id="95" name="组合 94"/>
            <p:cNvGrpSpPr/>
            <p:nvPr/>
          </p:nvGrpSpPr>
          <p:grpSpPr>
            <a:xfrm>
              <a:off x="322092" y="3838145"/>
              <a:ext cx="1897815" cy="323653"/>
              <a:chOff x="750124" y="611808"/>
              <a:chExt cx="1897815" cy="323653"/>
            </a:xfrm>
          </p:grpSpPr>
          <p:sp>
            <p:nvSpPr>
              <p:cNvPr id="97" name="TextBox 235"/>
              <p:cNvSpPr txBox="1"/>
              <p:nvPr/>
            </p:nvSpPr>
            <p:spPr>
              <a:xfrm rot="2249819">
                <a:off x="750124" y="656639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2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TextBox 235"/>
              <p:cNvSpPr txBox="1"/>
              <p:nvPr/>
            </p:nvSpPr>
            <p:spPr>
              <a:xfrm rot="2249819">
                <a:off x="989649" y="658462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2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TextBox 235"/>
              <p:cNvSpPr txBox="1"/>
              <p:nvPr/>
            </p:nvSpPr>
            <p:spPr>
              <a:xfrm rot="2249819">
                <a:off x="1094212" y="611808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2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6" name="TextBox 235"/>
            <p:cNvSpPr txBox="1"/>
            <p:nvPr/>
          </p:nvSpPr>
          <p:spPr>
            <a:xfrm rot="2249819">
              <a:off x="930389" y="3839323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0" name="组合 99"/>
          <p:cNvGrpSpPr/>
          <p:nvPr/>
        </p:nvGrpSpPr>
        <p:grpSpPr>
          <a:xfrm>
            <a:off x="2862395" y="3835410"/>
            <a:ext cx="2162024" cy="326034"/>
            <a:chOff x="322092" y="3861955"/>
            <a:chExt cx="2162024" cy="326034"/>
          </a:xfrm>
        </p:grpSpPr>
        <p:grpSp>
          <p:nvGrpSpPr>
            <p:cNvPr id="101" name="组合 100"/>
            <p:cNvGrpSpPr/>
            <p:nvPr/>
          </p:nvGrpSpPr>
          <p:grpSpPr>
            <a:xfrm>
              <a:off x="322092" y="3861955"/>
              <a:ext cx="1897815" cy="326034"/>
              <a:chOff x="750124" y="635618"/>
              <a:chExt cx="1897815" cy="326034"/>
            </a:xfrm>
          </p:grpSpPr>
          <p:sp>
            <p:nvSpPr>
              <p:cNvPr id="103" name="TextBox 235"/>
              <p:cNvSpPr txBox="1"/>
              <p:nvPr/>
            </p:nvSpPr>
            <p:spPr>
              <a:xfrm rot="2249819">
                <a:off x="750124" y="680449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3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Box 235"/>
              <p:cNvSpPr txBox="1"/>
              <p:nvPr/>
            </p:nvSpPr>
            <p:spPr>
              <a:xfrm rot="2249819">
                <a:off x="989649" y="684653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3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TextBox 235"/>
              <p:cNvSpPr txBox="1"/>
              <p:nvPr/>
            </p:nvSpPr>
            <p:spPr>
              <a:xfrm rot="2249819">
                <a:off x="1094212" y="635618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3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2" name="TextBox 235"/>
            <p:cNvSpPr txBox="1"/>
            <p:nvPr/>
          </p:nvSpPr>
          <p:spPr>
            <a:xfrm rot="2249819">
              <a:off x="930389" y="3863133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6" name="组合 105"/>
          <p:cNvGrpSpPr/>
          <p:nvPr/>
        </p:nvGrpSpPr>
        <p:grpSpPr>
          <a:xfrm>
            <a:off x="3928876" y="3832302"/>
            <a:ext cx="2162024" cy="326034"/>
            <a:chOff x="322092" y="3861955"/>
            <a:chExt cx="2162024" cy="326034"/>
          </a:xfrm>
        </p:grpSpPr>
        <p:grpSp>
          <p:nvGrpSpPr>
            <p:cNvPr id="107" name="组合 106"/>
            <p:cNvGrpSpPr/>
            <p:nvPr/>
          </p:nvGrpSpPr>
          <p:grpSpPr>
            <a:xfrm>
              <a:off x="322092" y="3861955"/>
              <a:ext cx="1897815" cy="326034"/>
              <a:chOff x="750124" y="635618"/>
              <a:chExt cx="1897815" cy="326034"/>
            </a:xfrm>
          </p:grpSpPr>
          <p:sp>
            <p:nvSpPr>
              <p:cNvPr id="109" name="TextBox 235"/>
              <p:cNvSpPr txBox="1"/>
              <p:nvPr/>
            </p:nvSpPr>
            <p:spPr>
              <a:xfrm rot="2249819">
                <a:off x="750124" y="680449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4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TextBox 235"/>
              <p:cNvSpPr txBox="1"/>
              <p:nvPr/>
            </p:nvSpPr>
            <p:spPr>
              <a:xfrm rot="2249819">
                <a:off x="989649" y="684653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4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TextBox 235"/>
              <p:cNvSpPr txBox="1"/>
              <p:nvPr/>
            </p:nvSpPr>
            <p:spPr>
              <a:xfrm rot="2249819">
                <a:off x="1094212" y="635618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4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8" name="TextBox 235"/>
            <p:cNvSpPr txBox="1"/>
            <p:nvPr/>
          </p:nvSpPr>
          <p:spPr>
            <a:xfrm rot="2249819">
              <a:off x="930389" y="3863133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4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2" name="组合 111"/>
          <p:cNvGrpSpPr/>
          <p:nvPr/>
        </p:nvGrpSpPr>
        <p:grpSpPr>
          <a:xfrm>
            <a:off x="5466034" y="3835882"/>
            <a:ext cx="2162024" cy="326034"/>
            <a:chOff x="322092" y="3861955"/>
            <a:chExt cx="2162024" cy="326034"/>
          </a:xfrm>
        </p:grpSpPr>
        <p:grpSp>
          <p:nvGrpSpPr>
            <p:cNvPr id="113" name="组合 112"/>
            <p:cNvGrpSpPr/>
            <p:nvPr/>
          </p:nvGrpSpPr>
          <p:grpSpPr>
            <a:xfrm>
              <a:off x="322092" y="3861955"/>
              <a:ext cx="1897815" cy="326034"/>
              <a:chOff x="750124" y="635618"/>
              <a:chExt cx="1897815" cy="326034"/>
            </a:xfrm>
          </p:grpSpPr>
          <p:sp>
            <p:nvSpPr>
              <p:cNvPr id="115" name="TextBox 235"/>
              <p:cNvSpPr txBox="1"/>
              <p:nvPr/>
            </p:nvSpPr>
            <p:spPr>
              <a:xfrm rot="2249819">
                <a:off x="750124" y="680449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5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TextBox 235"/>
              <p:cNvSpPr txBox="1"/>
              <p:nvPr/>
            </p:nvSpPr>
            <p:spPr>
              <a:xfrm rot="2249819">
                <a:off x="989649" y="684653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5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TextBox 235"/>
              <p:cNvSpPr txBox="1"/>
              <p:nvPr/>
            </p:nvSpPr>
            <p:spPr>
              <a:xfrm rot="2249819">
                <a:off x="1094212" y="635618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5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4" name="TextBox 235"/>
            <p:cNvSpPr txBox="1"/>
            <p:nvPr/>
          </p:nvSpPr>
          <p:spPr>
            <a:xfrm rot="2249819">
              <a:off x="930389" y="3863133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8" name="组合 117"/>
          <p:cNvGrpSpPr/>
          <p:nvPr/>
        </p:nvGrpSpPr>
        <p:grpSpPr>
          <a:xfrm>
            <a:off x="6535704" y="3838066"/>
            <a:ext cx="2162024" cy="326034"/>
            <a:chOff x="322092" y="3861955"/>
            <a:chExt cx="2162024" cy="326034"/>
          </a:xfrm>
        </p:grpSpPr>
        <p:grpSp>
          <p:nvGrpSpPr>
            <p:cNvPr id="119" name="组合 118"/>
            <p:cNvGrpSpPr/>
            <p:nvPr/>
          </p:nvGrpSpPr>
          <p:grpSpPr>
            <a:xfrm>
              <a:off x="322092" y="3861955"/>
              <a:ext cx="1897815" cy="326034"/>
              <a:chOff x="750124" y="635618"/>
              <a:chExt cx="1897815" cy="326034"/>
            </a:xfrm>
          </p:grpSpPr>
          <p:sp>
            <p:nvSpPr>
              <p:cNvPr id="121" name="TextBox 235"/>
              <p:cNvSpPr txBox="1"/>
              <p:nvPr/>
            </p:nvSpPr>
            <p:spPr>
              <a:xfrm rot="2249819">
                <a:off x="750124" y="680449"/>
                <a:ext cx="1267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Vehicle6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TextBox 235"/>
              <p:cNvSpPr txBox="1"/>
              <p:nvPr/>
            </p:nvSpPr>
            <p:spPr>
              <a:xfrm rot="2249819">
                <a:off x="989649" y="684653"/>
                <a:ext cx="1349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AS + Vehicle6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Box 235"/>
              <p:cNvSpPr txBox="1"/>
              <p:nvPr/>
            </p:nvSpPr>
            <p:spPr>
              <a:xfrm rot="2249819">
                <a:off x="1094212" y="635618"/>
                <a:ext cx="1553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699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39800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7096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2795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8494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4193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989299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559198" algn="l" defTabSz="1139800" rtl="0" eaLnBrk="1" latinLnBrk="0" hangingPunct="1">
                  <a:defRPr sz="2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HC + Cefazolin6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0" name="TextBox 235"/>
            <p:cNvSpPr txBox="1"/>
            <p:nvPr/>
          </p:nvSpPr>
          <p:spPr>
            <a:xfrm rot="2249819">
              <a:off x="930389" y="3863133"/>
              <a:ext cx="1553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699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39800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7096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2795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8494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4193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989299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559198" algn="l" defTabSz="1139800" rtl="0" eaLnBrk="1" latinLnBrk="0" hangingPunct="1">
                <a:defRPr sz="2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S + Cefazolin6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3" name="Picture 2" descr="C:\Users\win10\Desktop\原始条带\抗生素\gapdh 21.tif"/>
          <p:cNvPicPr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9769" y="5691796"/>
            <a:ext cx="2520000" cy="360362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3" descr="C:\Users\win10\Desktop\原始条带\抗生素\gapdh31.tif"/>
          <p:cNvPicPr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0360" y="5676774"/>
            <a:ext cx="2520000" cy="360363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4" descr="C:\Users\win10\Desktop\原始条带\抗生素\ZO34 2.tif"/>
          <p:cNvPicPr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7396" y="4400342"/>
            <a:ext cx="2520000" cy="53975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92027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7</TotalTime>
  <Words>121</Words>
  <Application>Microsoft Office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10</dc:creator>
  <cp:lastModifiedBy>Sandhya Patel</cp:lastModifiedBy>
  <cp:revision>17</cp:revision>
  <dcterms:created xsi:type="dcterms:W3CDTF">2021-07-17T10:01:24Z</dcterms:created>
  <dcterms:modified xsi:type="dcterms:W3CDTF">2021-10-06T16:41:33Z</dcterms:modified>
</cp:coreProperties>
</file>